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A5A6D-115B-4299-94C9-BAE838175F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6F8BA-A61B-41EB-969C-113715BA2E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9DC24-0371-4ABB-B002-C6ADC49ED3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BF50E-C517-42E3-B377-797968E88B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0659A-6831-46C3-A98E-F21093EBF6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BD37A-3647-4EF1-B4CE-A1A441D535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0F73A-052E-4B93-B0D6-40E29AEFF3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BFD1F-9353-48E8-9867-F2247B5381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2C221-E888-4AFA-8A2F-8929B7B1B4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E8553-2F90-4B61-9CC4-491084EF5B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57911-D7F5-418B-AB42-310FB998D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B05A2-061D-44AC-A6A5-2F1190063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8D0B0A-BC65-4796-A847-8B8C834128C1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1" name="肘形连接符 31"/>
          <p:cNvCxnSpPr/>
          <p:nvPr/>
        </p:nvCxnSpPr>
        <p:spPr>
          <a:xfrm rot="5400000">
            <a:off x="3142080" y="1435680"/>
            <a:ext cx="532440" cy="489600"/>
          </a:xfrm>
          <a:prstGeom prst="bentConnector3">
            <a:avLst>
              <a:gd name="adj1" fmla="val 50879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2" name="肘形连接符 16"/>
          <p:cNvCxnSpPr/>
          <p:nvPr/>
        </p:nvCxnSpPr>
        <p:spPr>
          <a:xfrm flipH="1" rot="16200000">
            <a:off x="2652120" y="1440360"/>
            <a:ext cx="532800" cy="489600"/>
          </a:xfrm>
          <a:prstGeom prst="bentConnector3">
            <a:avLst>
              <a:gd name="adj1" fmla="val 49966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graphicFrame>
        <p:nvGraphicFramePr>
          <p:cNvPr id="43" name=""/>
          <p:cNvGraphicFramePr/>
          <p:nvPr/>
        </p:nvGraphicFramePr>
        <p:xfrm>
          <a:off x="2374920" y="560520"/>
          <a:ext cx="6524640" cy="890280"/>
        </p:xfrm>
        <a:graphic>
          <a:graphicData uri="http://schemas.openxmlformats.org/drawingml/2006/table">
            <a:tbl>
              <a:tblPr/>
              <a:tblGrid>
                <a:gridCol w="544320"/>
                <a:gridCol w="543240"/>
                <a:gridCol w="542880"/>
                <a:gridCol w="544320"/>
                <a:gridCol w="542880"/>
                <a:gridCol w="544680"/>
                <a:gridCol w="544320"/>
                <a:gridCol w="543240"/>
                <a:gridCol w="542880"/>
                <a:gridCol w="544320"/>
                <a:gridCol w="542880"/>
                <a:gridCol w="544680"/>
              </a:tblGrid>
              <a:tr h="446040">
                <a:tc gridSpan="1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ffffff"/>
                          </a:solidFill>
                          <a:latin typeface="Arial"/>
                          <a:ea typeface="宋体"/>
                        </a:rPr>
                        <a:t>Eligible birth months for study inclus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5b9bd5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442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J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e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M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pri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Ma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Ju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Jul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u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e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ov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De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2deef"/>
                    </a:solidFill>
                  </a:tcPr>
                </a:tc>
              </a:tr>
            </a:tbl>
          </a:graphicData>
        </a:graphic>
      </p:graphicFrame>
      <p:sp>
        <p:nvSpPr>
          <p:cNvPr id="44" name="TextBox 7"/>
          <p:cNvSpPr/>
          <p:nvPr/>
        </p:nvSpPr>
        <p:spPr>
          <a:xfrm>
            <a:off x="2374920" y="1951200"/>
            <a:ext cx="1576440" cy="55080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Excluded because not enough data about at least one trimest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3570120" y="2735280"/>
            <a:ext cx="2424240" cy="24624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Only included in the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宋体"/>
              </a:rPr>
              <a:t>3r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trimester grou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6"/>
          <p:cNvSpPr/>
          <p:nvPr/>
        </p:nvSpPr>
        <p:spPr>
          <a:xfrm>
            <a:off x="5181480" y="3193920"/>
            <a:ext cx="2495520" cy="39852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ncluded in both the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宋体"/>
              </a:rPr>
              <a:t>3r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trimester group and the </a:t>
            </a:r>
            <a:r>
              <a:rPr b="0" lang="en-US" sz="1000" spc="-1" strike="noStrike">
                <a:solidFill>
                  <a:srgbClr val="00b050"/>
                </a:solidFill>
                <a:latin typeface="Arial"/>
                <a:ea typeface="宋体"/>
              </a:rPr>
              <a:t>2n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trimester grou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8"/>
          <p:cNvSpPr/>
          <p:nvPr/>
        </p:nvSpPr>
        <p:spPr>
          <a:xfrm>
            <a:off x="7183440" y="3824280"/>
            <a:ext cx="1716120" cy="70308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nclude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in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宋体"/>
              </a:rPr>
              <a:t>3r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trimester, </a:t>
            </a:r>
            <a:r>
              <a:rPr b="0" lang="en-US" sz="1000" spc="-1" strike="noStrike">
                <a:solidFill>
                  <a:srgbClr val="00b050"/>
                </a:solidFill>
                <a:latin typeface="Arial"/>
                <a:ea typeface="宋体"/>
              </a:rPr>
              <a:t>2nd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trimester and </a:t>
            </a:r>
            <a:r>
              <a:rPr b="0" lang="en-US" sz="1000" spc="-1" strike="noStrike">
                <a:solidFill>
                  <a:srgbClr val="0070c0"/>
                </a:solidFill>
                <a:latin typeface="Arial"/>
                <a:ea typeface="宋体"/>
              </a:rPr>
              <a:t>1s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trimester group, as well as the entire pregnancy grou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"/>
          <p:cNvSpPr/>
          <p:nvPr/>
        </p:nvSpPr>
        <p:spPr>
          <a:xfrm>
            <a:off x="2374920" y="4508640"/>
            <a:ext cx="65944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o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7946 women in group-T3= singleton deliveries identified from April to Decemb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5377 women in group-T2= singleton deliveries from July to Decemb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2896 women in group-T1 or group-Entire Pregnancy= singleton deliveries from October to December, which is the same as the entire trimeste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9" name="直接箭头连接符 21"/>
          <p:cNvCxnSpPr>
            <a:endCxn id="44" idx="0"/>
          </p:cNvCxnSpPr>
          <p:nvPr/>
        </p:nvCxnSpPr>
        <p:spPr>
          <a:xfrm flipH="1">
            <a:off x="3162960" y="1450800"/>
            <a:ext cx="1080" cy="500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0" name="肘形连接符 29"/>
          <p:cNvCxnSpPr>
            <a:endCxn id="45" idx="0"/>
          </p:cNvCxnSpPr>
          <p:nvPr/>
        </p:nvCxnSpPr>
        <p:spPr>
          <a:xfrm flipH="1" rot="16200000">
            <a:off x="3863520" y="1816560"/>
            <a:ext cx="1284840" cy="553320"/>
          </a:xfrm>
          <a:prstGeom prst="bentConnector3">
            <a:avLst>
              <a:gd name="adj1" fmla="val 41003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肘形连接符 32"/>
          <p:cNvCxnSpPr>
            <a:endCxn id="45" idx="0"/>
          </p:cNvCxnSpPr>
          <p:nvPr/>
        </p:nvCxnSpPr>
        <p:spPr>
          <a:xfrm flipH="1" rot="16200000">
            <a:off x="4139640" y="2092680"/>
            <a:ext cx="1284840" cy="1080"/>
          </a:xfrm>
          <a:prstGeom prst="bentConnector3">
            <a:avLst>
              <a:gd name="adj1" fmla="val 41003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肘形连接符 34"/>
          <p:cNvCxnSpPr>
            <a:endCxn id="45" idx="0"/>
          </p:cNvCxnSpPr>
          <p:nvPr/>
        </p:nvCxnSpPr>
        <p:spPr>
          <a:xfrm rot="5400000">
            <a:off x="4439520" y="1793520"/>
            <a:ext cx="1284840" cy="599400"/>
          </a:xfrm>
          <a:prstGeom prst="bentConnector3">
            <a:avLst>
              <a:gd name="adj1" fmla="val 41003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" name="肘形连接符 47"/>
          <p:cNvCxnSpPr>
            <a:endCxn id="46" idx="0"/>
          </p:cNvCxnSpPr>
          <p:nvPr/>
        </p:nvCxnSpPr>
        <p:spPr>
          <a:xfrm flipH="1" rot="16200000">
            <a:off x="5257800" y="2022480"/>
            <a:ext cx="1780200" cy="563400"/>
          </a:xfrm>
          <a:prstGeom prst="bentConnector3">
            <a:avLst>
              <a:gd name="adj1" fmla="val 43487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4" name="肘形连接符 54"/>
          <p:cNvCxnSpPr>
            <a:endCxn id="46" idx="0"/>
          </p:cNvCxnSpPr>
          <p:nvPr/>
        </p:nvCxnSpPr>
        <p:spPr>
          <a:xfrm rot="5400000">
            <a:off x="5813280" y="2066760"/>
            <a:ext cx="1743480" cy="511560"/>
          </a:xfrm>
          <a:prstGeom prst="bentConnector3">
            <a:avLst>
              <a:gd name="adj1" fmla="val 43349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5" name="直接箭头连接符 58"/>
          <p:cNvCxnSpPr/>
          <p:nvPr/>
        </p:nvCxnSpPr>
        <p:spPr>
          <a:xfrm>
            <a:off x="6428880" y="1450800"/>
            <a:ext cx="1080" cy="1743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肘形连接符 60"/>
          <p:cNvCxnSpPr/>
          <p:nvPr/>
        </p:nvCxnSpPr>
        <p:spPr>
          <a:xfrm flipH="1" rot="16200000">
            <a:off x="6622920" y="2350440"/>
            <a:ext cx="2374200" cy="573840"/>
          </a:xfrm>
          <a:prstGeom prst="bentConnector3">
            <a:avLst>
              <a:gd name="adj1" fmla="val 50000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直接箭头连接符 2048"/>
          <p:cNvCxnSpPr/>
          <p:nvPr/>
        </p:nvCxnSpPr>
        <p:spPr>
          <a:xfrm flipH="1">
            <a:off x="8095680" y="1454040"/>
            <a:ext cx="1080" cy="2370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8" name="肘形连接符 26"/>
          <p:cNvCxnSpPr/>
          <p:nvPr/>
        </p:nvCxnSpPr>
        <p:spPr>
          <a:xfrm rot="5400000">
            <a:off x="7173720" y="2370600"/>
            <a:ext cx="2370960" cy="531000"/>
          </a:xfrm>
          <a:prstGeom prst="bentConnector3">
            <a:avLst>
              <a:gd name="adj1" fmla="val 49719"/>
            </a:avLst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9" name="TextBox 3"/>
          <p:cNvSpPr/>
          <p:nvPr/>
        </p:nvSpPr>
        <p:spPr>
          <a:xfrm>
            <a:off x="3054240" y="5548320"/>
            <a:ext cx="523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1 Detailed information of sample extraction proce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26T07:34:38Z</dcterms:created>
  <dc:creator>carolinaung</dc:creator>
  <dc:description/>
  <dc:language>en-US</dc:language>
  <cp:lastModifiedBy>Z Jessie</cp:lastModifiedBy>
  <dcterms:modified xsi:type="dcterms:W3CDTF">2019-08-12T04:20:48Z</dcterms:modified>
  <cp:revision>24</cp:revision>
  <dc:subject/>
  <dc:title>PowerPoint Presentation</dc:title>
</cp:coreProperties>
</file>